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  <p:sldId id="260" r:id="rId5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37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0CE224-5E12-4B63-B5C6-4161902D1366}" type="datetimeFigureOut">
              <a:rPr lang="de-DE" smtClean="0"/>
              <a:pPr/>
              <a:t>19.09.201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A344EE-59E6-4250-886B-4D9A8F39FD13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 descr="Figure.03_Linkage.map.22LG.100223.tiff"/>
          <p:cNvPicPr>
            <a:picLocks noChangeAspect="1"/>
          </p:cNvPicPr>
          <p:nvPr/>
        </p:nvPicPr>
        <p:blipFill>
          <a:blip r:embed="rId2" cstate="print"/>
          <a:srcRect l="8730" t="4949" r="7282" b="5972"/>
          <a:stretch>
            <a:fillRect/>
          </a:stretch>
        </p:blipFill>
        <p:spPr>
          <a:xfrm>
            <a:off x="395536" y="296652"/>
            <a:ext cx="8352928" cy="6264696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0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igure S2</a:t>
            </a: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1080112" y="6611779"/>
            <a:ext cx="450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itchFamily="34" charset="0"/>
                <a:cs typeface="Arial" pitchFamily="34" charset="0"/>
              </a:rPr>
              <a:t>Second-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generatio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genetic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linkage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map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N. furzeri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igure S3</a:t>
            </a:r>
            <a:endParaRPr lang="de-DE" dirty="0"/>
          </a:p>
        </p:txBody>
      </p:sp>
      <p:pic>
        <p:nvPicPr>
          <p:cNvPr id="3" name="Grafik 2" descr="Figure.S02_Oxford.grid.100817.tiff"/>
          <p:cNvPicPr>
            <a:picLocks noChangeAspect="1"/>
          </p:cNvPicPr>
          <p:nvPr/>
        </p:nvPicPr>
        <p:blipFill>
          <a:blip r:embed="rId2" cstate="print"/>
          <a:srcRect t="5901" b="48950"/>
          <a:stretch>
            <a:fillRect/>
          </a:stretch>
        </p:blipFill>
        <p:spPr>
          <a:xfrm>
            <a:off x="790956" y="1015936"/>
            <a:ext cx="7562088" cy="4826128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1080112" y="6488668"/>
            <a:ext cx="76683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itchFamily="34" charset="0"/>
                <a:cs typeface="Arial" pitchFamily="34" charset="0"/>
              </a:rPr>
              <a:t>Oxford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plot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N.furzeri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and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medaka. On the y-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axi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N. furzeri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linkage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group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are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show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, on the x-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axi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, medaka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chromosome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are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give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. Numbers in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boxe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represent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the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number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N.furzeri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marker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showing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synteny on a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give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medaka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chromosome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648866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igure S4</a:t>
            </a:r>
            <a:endParaRPr lang="de-DE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r="3121"/>
          <a:stretch>
            <a:fillRect/>
          </a:stretch>
        </p:blipFill>
        <p:spPr bwMode="auto">
          <a:xfrm>
            <a:off x="1403648" y="116632"/>
            <a:ext cx="6336704" cy="65474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feld 4"/>
          <p:cNvSpPr txBox="1"/>
          <p:nvPr/>
        </p:nvSpPr>
        <p:spPr>
          <a:xfrm>
            <a:off x="1080112" y="6611779"/>
            <a:ext cx="4500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Lifespa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of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cros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B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143" y="625937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Figure S5</a:t>
            </a:r>
            <a:endParaRPr lang="de-DE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 cstate="print"/>
          <a:srcRect l="877" t="1250" r="877" b="1250"/>
          <a:stretch>
            <a:fillRect/>
          </a:stretch>
        </p:blipFill>
        <p:spPr bwMode="auto">
          <a:xfrm>
            <a:off x="1286243" y="1140714"/>
            <a:ext cx="6571514" cy="45765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Textfeld 8"/>
          <p:cNvSpPr txBox="1"/>
          <p:nvPr/>
        </p:nvSpPr>
        <p:spPr>
          <a:xfrm>
            <a:off x="1080112" y="6304002"/>
            <a:ext cx="4500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 smtClean="0">
                <a:latin typeface="Arial" pitchFamily="34" charset="0"/>
                <a:cs typeface="Arial" pitchFamily="34" charset="0"/>
              </a:rPr>
              <a:t>Initial QTL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sca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for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lifespa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with all F</a:t>
            </a:r>
            <a:r>
              <a:rPr lang="de-DE" sz="10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included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.</a:t>
            </a:r>
          </a:p>
          <a:p>
            <a:r>
              <a:rPr lang="de-DE" sz="1000" dirty="0" smtClean="0">
                <a:latin typeface="Arial" pitchFamily="34" charset="0"/>
                <a:cs typeface="Arial" pitchFamily="34" charset="0"/>
              </a:rPr>
              <a:t>Based on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our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statistical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analyse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, maximal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body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weight was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included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as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a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covariate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 in the QTL </a:t>
            </a:r>
            <a:r>
              <a:rPr lang="de-DE" sz="1000" dirty="0" err="1" smtClean="0">
                <a:latin typeface="Arial" pitchFamily="34" charset="0"/>
                <a:cs typeface="Arial" pitchFamily="34" charset="0"/>
              </a:rPr>
              <a:t>scan</a:t>
            </a:r>
            <a:r>
              <a:rPr lang="de-DE" sz="1000" dirty="0" smtClean="0">
                <a:latin typeface="Arial" pitchFamily="34" charset="0"/>
                <a:cs typeface="Arial" pitchFamily="34" charset="0"/>
              </a:rPr>
              <a:t>.</a:t>
            </a:r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3" cstate="print"/>
          <a:srcRect l="10117" t="16313" r="70709" b="72496"/>
          <a:stretch>
            <a:fillRect/>
          </a:stretch>
        </p:blipFill>
        <p:spPr bwMode="auto">
          <a:xfrm>
            <a:off x="7020272" y="6021288"/>
            <a:ext cx="1800024" cy="6822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C8E0D8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6</Words>
  <Application>Microsoft Office PowerPoint</Application>
  <PresentationFormat>Bildschirmpräsentation (4:3)</PresentationFormat>
  <Paragraphs>9</Paragraphs>
  <Slides>4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Larissa-Design</vt:lpstr>
      <vt:lpstr>Folie 1</vt:lpstr>
      <vt:lpstr>Folie 2</vt:lpstr>
      <vt:lpstr>Folie 3</vt:lpstr>
      <vt:lpstr>Folie 4</vt:lpstr>
    </vt:vector>
  </TitlesOfParts>
  <Company>test e.V.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Kathrin Reichwald</dc:creator>
  <cp:lastModifiedBy>Kathrin Reichwald</cp:lastModifiedBy>
  <cp:revision>9</cp:revision>
  <dcterms:created xsi:type="dcterms:W3CDTF">2011-06-29T17:44:20Z</dcterms:created>
  <dcterms:modified xsi:type="dcterms:W3CDTF">2011-09-19T08:35:27Z</dcterms:modified>
</cp:coreProperties>
</file>